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776EC15-138E-4F10-9CEE-A93598040F78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7A79269-1B2E-4BE5-A13A-7863D3EBE2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3A5314D-6680-4A17-8814-900A5C3A76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2684324-39DB-4CED-B0CE-6385CD29F6A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708D99D-ED55-4ED3-8CD0-EFDC51200E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065B283-CC54-47E4-BD9C-FF4AF37B23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31E3BF4-97B8-47EC-8B23-97AC9C2B38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2C08BBC-8A89-4FDC-AB80-F661A6FB7B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2FEC871-73F7-4B7C-8DE8-365FF83870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33C156B-DC80-4615-99E8-0AB28F6EB5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C733B27-26C3-4E1E-8504-9DA52155B5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177E094-351A-40CD-864E-4D8552A7C0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/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10097C2-9F46-495E-993A-F99AAD044FF9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tuberculist.epfl.ch/index.html" TargetMode="External"/><Relationship Id="rId2" Type="http://schemas.openxmlformats.org/officeDocument/2006/relationships/hyperlink" Target="http://tuberculist.epfl.ch/index.html" TargetMode="External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14440" y="1371600"/>
          <a:ext cx="5828760" cy="6879960"/>
        </p:xfrm>
        <a:graphic>
          <a:graphicData uri="http://schemas.openxmlformats.org/drawingml/2006/table">
            <a:tbl>
              <a:tblPr/>
              <a:tblGrid>
                <a:gridCol w="1125360"/>
                <a:gridCol w="1333800"/>
                <a:gridCol w="3369600"/>
              </a:tblGrid>
              <a:tr h="58140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v093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tein Produc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    </a:t>
                      </a:r>
                      <a:r>
                        <a:rPr b="0" lang="en-US" sz="2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iological activity*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93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100872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0934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stS1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unctions in active transport of inorganic phosphate across the membrane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936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  <a:tr h="71316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0831c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ypo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served protein of function unknown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71316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3804c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bpA (85A)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unction in cell wall mycoloylation. 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  <a:tr h="71352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3881c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spB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served Alanine/Glycine-rich protein of function unknown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71316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3841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frB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racellular molecule involved in iron storage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  <a:tr h="71316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2031c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spX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mall heat shock protein prosed to gave a role in early infection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</a:tr>
              <a:tr h="100872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0054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sb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ngle-stranded DNA binding protein essential for DNA replication of chromosomes.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d0d8e7"/>
                    </a:solidFill>
                  </a:tcPr>
                </a:tc>
              </a:tr>
              <a:tr h="714960"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v1980c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51120" rIns="51120" tIns="0" bIns="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pt64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120" marR="5112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  <a:tc>
                  <a:txBody>
                    <a:bodyPr lIns="68400" rIns="68400" tIns="60840" bIns="60840" anchor="t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5067360"/>
                          <a:tab algn="l" pos="579132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creted protein of unknown function</a:t>
                      </a:r>
                      <a:endParaRPr b="0" lang="en-US" sz="1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400" marR="68400">
                    <a:lnL w="2880">
                      <a:solidFill>
                        <a:srgbClr val="ffffff"/>
                      </a:solidFill>
                    </a:lnL>
                    <a:lnR w="2880">
                      <a:solidFill>
                        <a:srgbClr val="ffffff"/>
                      </a:solidFill>
                    </a:lnR>
                    <a:lnT w="2880">
                      <a:solidFill>
                        <a:srgbClr val="ffffff"/>
                      </a:solidFill>
                    </a:lnT>
                    <a:lnB w="2880">
                      <a:solidFill>
                        <a:srgbClr val="ffffff"/>
                      </a:solidFill>
                    </a:lnB>
                    <a:solidFill>
                      <a:srgbClr val="e9ecf3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285840" y="541440"/>
            <a:ext cx="605772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4: Table S3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iological activity of the eigh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                                   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formative MTB protein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16000" y="8389800"/>
            <a:ext cx="6095880" cy="56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* Biological activity obtained from the TB data base, TubercuList (see </a:t>
            </a:r>
            <a:r>
              <a:rPr b="0" lang="en-US" sz="1400" spc="-1" strike="noStrike" u="sng">
                <a:solidFill>
                  <a:srgbClr val="ccccff"/>
                </a:solidFill>
                <a:uFillTx/>
                <a:latin typeface="Calibri"/>
                <a:hlinkClick r:id="rId1"/>
              </a:rPr>
              <a:t>http://</a:t>
            </a:r>
            <a:r>
              <a:rPr b="0" lang="en-US" sz="1400" spc="-1" strike="noStrike" u="sng">
                <a:solidFill>
                  <a:srgbClr val="ccccff"/>
                </a:solidFill>
                <a:uFillTx/>
                <a:latin typeface="Calibri"/>
                <a:hlinkClick r:id="rId2"/>
              </a:rPr>
              <a:t>tuberculist.epfl.ch/index.html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